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CustomShape 1"/>
          <p:cNvSpPr/>
          <p:nvPr/>
        </p:nvSpPr>
        <p:spPr>
          <a:xfrm>
            <a:off x="822960" y="4822200"/>
            <a:ext cx="8262000" cy="85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400" spc="-1" strike="noStrike">
                <a:solidFill>
                  <a:srgbClr val="000000"/>
                </a:solidFill>
                <a:latin typeface="Time"/>
                <a:ea typeface="DejaVu Sans"/>
              </a:rPr>
              <a:t>Supplementary Figure 3</a:t>
            </a:r>
            <a:r>
              <a:rPr b="0" lang="en-US" sz="1400" spc="-1" strike="noStrike">
                <a:solidFill>
                  <a:srgbClr val="000000"/>
                </a:solidFill>
                <a:latin typeface="Time"/>
                <a:ea typeface="DejaVu Sans"/>
              </a:rPr>
              <a:t> - Evolution of the number of cytogenetic analyses carried out in France between 2008 and 2020 (in black), and of the proportion of individuals with 2n=37 or 38 chromosomes (cytogenetical hybrids, in blue).</a:t>
            </a:r>
            <a:endParaRPr b="0" lang="fr-FR" sz="1400" spc="-1" strike="noStrike">
              <a:latin typeface="Arial"/>
            </a:endParaRPr>
          </a:p>
        </p:txBody>
      </p:sp>
      <p:pic>
        <p:nvPicPr>
          <p:cNvPr id="77" name="Image 176" descr=""/>
          <p:cNvPicPr/>
          <p:nvPr/>
        </p:nvPicPr>
        <p:blipFill>
          <a:blip r:embed="rId1"/>
          <a:stretch/>
        </p:blipFill>
        <p:spPr>
          <a:xfrm>
            <a:off x="1791720" y="548640"/>
            <a:ext cx="5705280" cy="356508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7:01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